
<file path=[Content_Types].xml><?xml version="1.0" encoding="utf-8"?>
<Types xmlns="http://schemas.openxmlformats.org/package/2006/content-types">
  <Default Extension="emf" ContentType="image/x-e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7" r:id="rId2"/>
  </p:sldIdLst>
  <p:sldSz cx="3060700" cy="3203575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3292" autoAdjust="0"/>
    <p:restoredTop sz="94660"/>
  </p:normalViewPr>
  <p:slideViewPr>
    <p:cSldViewPr snapToGrid="0">
      <p:cViewPr varScale="1">
        <p:scale>
          <a:sx n="178" d="100"/>
          <a:sy n="178" d="100"/>
        </p:scale>
        <p:origin x="2585" y="5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29553" y="524289"/>
            <a:ext cx="2601595" cy="1115319"/>
          </a:xfrm>
        </p:spPr>
        <p:txBody>
          <a:bodyPr anchor="b"/>
          <a:lstStyle>
            <a:lvl1pPr algn="ctr">
              <a:defRPr sz="200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82588" y="1682619"/>
            <a:ext cx="2295525" cy="773455"/>
          </a:xfrm>
        </p:spPr>
        <p:txBody>
          <a:bodyPr/>
          <a:lstStyle>
            <a:lvl1pPr marL="0" indent="0" algn="ctr">
              <a:buNone/>
              <a:defRPr sz="803"/>
            </a:lvl1pPr>
            <a:lvl2pPr marL="153025" indent="0" algn="ctr">
              <a:buNone/>
              <a:defRPr sz="669"/>
            </a:lvl2pPr>
            <a:lvl3pPr marL="306050" indent="0" algn="ctr">
              <a:buNone/>
              <a:defRPr sz="602"/>
            </a:lvl3pPr>
            <a:lvl4pPr marL="459075" indent="0" algn="ctr">
              <a:buNone/>
              <a:defRPr sz="536"/>
            </a:lvl4pPr>
            <a:lvl5pPr marL="612099" indent="0" algn="ctr">
              <a:buNone/>
              <a:defRPr sz="536"/>
            </a:lvl5pPr>
            <a:lvl6pPr marL="765124" indent="0" algn="ctr">
              <a:buNone/>
              <a:defRPr sz="536"/>
            </a:lvl6pPr>
            <a:lvl7pPr marL="918149" indent="0" algn="ctr">
              <a:buNone/>
              <a:defRPr sz="536"/>
            </a:lvl7pPr>
            <a:lvl8pPr marL="1071174" indent="0" algn="ctr">
              <a:buNone/>
              <a:defRPr sz="536"/>
            </a:lvl8pPr>
            <a:lvl9pPr marL="1224199" indent="0" algn="ctr">
              <a:buNone/>
              <a:defRPr sz="536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A9B4-639C-428F-9083-3B99A71CCE52}" type="datetimeFigureOut">
              <a:rPr kumimoji="1" lang="ja-JP" altLang="en-US" smtClean="0"/>
              <a:t>2020/9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58706-EEC3-45D8-A4BD-7C0559D814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07734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A9B4-639C-428F-9083-3B99A71CCE52}" type="datetimeFigureOut">
              <a:rPr kumimoji="1" lang="ja-JP" altLang="en-US" smtClean="0"/>
              <a:t>2020/9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58706-EEC3-45D8-A4BD-7C0559D814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657192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190314" y="170561"/>
            <a:ext cx="659963" cy="2714882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10423" y="170561"/>
            <a:ext cx="1941632" cy="2714882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A9B4-639C-428F-9083-3B99A71CCE52}" type="datetimeFigureOut">
              <a:rPr kumimoji="1" lang="ja-JP" altLang="en-US" smtClean="0"/>
              <a:t>2020/9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58706-EEC3-45D8-A4BD-7C0559D814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95897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A9B4-639C-428F-9083-3B99A71CCE52}" type="datetimeFigureOut">
              <a:rPr kumimoji="1" lang="ja-JP" altLang="en-US" smtClean="0"/>
              <a:t>2020/9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58706-EEC3-45D8-A4BD-7C0559D814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07710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08829" y="798670"/>
            <a:ext cx="2639854" cy="1332598"/>
          </a:xfrm>
        </p:spPr>
        <p:txBody>
          <a:bodyPr anchor="b"/>
          <a:lstStyle>
            <a:lvl1pPr>
              <a:defRPr sz="2008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08829" y="2143875"/>
            <a:ext cx="2639854" cy="700782"/>
          </a:xfrm>
        </p:spPr>
        <p:txBody>
          <a:bodyPr/>
          <a:lstStyle>
            <a:lvl1pPr marL="0" indent="0">
              <a:buNone/>
              <a:defRPr sz="803">
                <a:solidFill>
                  <a:schemeClr val="tx1"/>
                </a:solidFill>
              </a:defRPr>
            </a:lvl1pPr>
            <a:lvl2pPr marL="153025" indent="0">
              <a:buNone/>
              <a:defRPr sz="669">
                <a:solidFill>
                  <a:schemeClr val="tx1">
                    <a:tint val="75000"/>
                  </a:schemeClr>
                </a:solidFill>
              </a:defRPr>
            </a:lvl2pPr>
            <a:lvl3pPr marL="306050" indent="0">
              <a:buNone/>
              <a:defRPr sz="602">
                <a:solidFill>
                  <a:schemeClr val="tx1">
                    <a:tint val="75000"/>
                  </a:schemeClr>
                </a:solidFill>
              </a:defRPr>
            </a:lvl3pPr>
            <a:lvl4pPr marL="459075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4pPr>
            <a:lvl5pPr marL="612099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5pPr>
            <a:lvl6pPr marL="765124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6pPr>
            <a:lvl7pPr marL="918149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7pPr>
            <a:lvl8pPr marL="1071174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8pPr>
            <a:lvl9pPr marL="1224199" indent="0">
              <a:buNone/>
              <a:defRPr sz="536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A9B4-639C-428F-9083-3B99A71CCE52}" type="datetimeFigureOut">
              <a:rPr kumimoji="1" lang="ja-JP" altLang="en-US" smtClean="0"/>
              <a:t>2020/9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58706-EEC3-45D8-A4BD-7C0559D814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2046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10423" y="852803"/>
            <a:ext cx="1300798" cy="203263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549479" y="852803"/>
            <a:ext cx="1300798" cy="2032639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A9B4-639C-428F-9083-3B99A71CCE52}" type="datetimeFigureOut">
              <a:rPr kumimoji="1" lang="ja-JP" altLang="en-US" smtClean="0"/>
              <a:t>2020/9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58706-EEC3-45D8-A4BD-7C0559D814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1589451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822" y="170561"/>
            <a:ext cx="2639854" cy="619210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0822" y="785321"/>
            <a:ext cx="1294819" cy="384874"/>
          </a:xfrm>
        </p:spPr>
        <p:txBody>
          <a:bodyPr anchor="b"/>
          <a:lstStyle>
            <a:lvl1pPr marL="0" indent="0">
              <a:buNone/>
              <a:defRPr sz="803" b="1"/>
            </a:lvl1pPr>
            <a:lvl2pPr marL="153025" indent="0">
              <a:buNone/>
              <a:defRPr sz="669" b="1"/>
            </a:lvl2pPr>
            <a:lvl3pPr marL="306050" indent="0">
              <a:buNone/>
              <a:defRPr sz="602" b="1"/>
            </a:lvl3pPr>
            <a:lvl4pPr marL="459075" indent="0">
              <a:buNone/>
              <a:defRPr sz="536" b="1"/>
            </a:lvl4pPr>
            <a:lvl5pPr marL="612099" indent="0">
              <a:buNone/>
              <a:defRPr sz="536" b="1"/>
            </a:lvl5pPr>
            <a:lvl6pPr marL="765124" indent="0">
              <a:buNone/>
              <a:defRPr sz="536" b="1"/>
            </a:lvl6pPr>
            <a:lvl7pPr marL="918149" indent="0">
              <a:buNone/>
              <a:defRPr sz="536" b="1"/>
            </a:lvl7pPr>
            <a:lvl8pPr marL="1071174" indent="0">
              <a:buNone/>
              <a:defRPr sz="536" b="1"/>
            </a:lvl8pPr>
            <a:lvl9pPr marL="1224199" indent="0">
              <a:buNone/>
              <a:defRPr sz="53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10822" y="1170195"/>
            <a:ext cx="1294819" cy="172118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549480" y="785321"/>
            <a:ext cx="1301196" cy="384874"/>
          </a:xfrm>
        </p:spPr>
        <p:txBody>
          <a:bodyPr anchor="b"/>
          <a:lstStyle>
            <a:lvl1pPr marL="0" indent="0">
              <a:buNone/>
              <a:defRPr sz="803" b="1"/>
            </a:lvl1pPr>
            <a:lvl2pPr marL="153025" indent="0">
              <a:buNone/>
              <a:defRPr sz="669" b="1"/>
            </a:lvl2pPr>
            <a:lvl3pPr marL="306050" indent="0">
              <a:buNone/>
              <a:defRPr sz="602" b="1"/>
            </a:lvl3pPr>
            <a:lvl4pPr marL="459075" indent="0">
              <a:buNone/>
              <a:defRPr sz="536" b="1"/>
            </a:lvl4pPr>
            <a:lvl5pPr marL="612099" indent="0">
              <a:buNone/>
              <a:defRPr sz="536" b="1"/>
            </a:lvl5pPr>
            <a:lvl6pPr marL="765124" indent="0">
              <a:buNone/>
              <a:defRPr sz="536" b="1"/>
            </a:lvl6pPr>
            <a:lvl7pPr marL="918149" indent="0">
              <a:buNone/>
              <a:defRPr sz="536" b="1"/>
            </a:lvl7pPr>
            <a:lvl8pPr marL="1071174" indent="0">
              <a:buNone/>
              <a:defRPr sz="536" b="1"/>
            </a:lvl8pPr>
            <a:lvl9pPr marL="1224199" indent="0">
              <a:buNone/>
              <a:defRPr sz="536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549480" y="1170195"/>
            <a:ext cx="1301196" cy="1721180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A9B4-639C-428F-9083-3B99A71CCE52}" type="datetimeFigureOut">
              <a:rPr kumimoji="1" lang="ja-JP" altLang="en-US" smtClean="0"/>
              <a:t>2020/9/1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58706-EEC3-45D8-A4BD-7C0559D814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795823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A9B4-639C-428F-9083-3B99A71CCE52}" type="datetimeFigureOut">
              <a:rPr kumimoji="1" lang="ja-JP" altLang="en-US" smtClean="0"/>
              <a:t>2020/9/1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58706-EEC3-45D8-A4BD-7C0559D814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925427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A9B4-639C-428F-9083-3B99A71CCE52}" type="datetimeFigureOut">
              <a:rPr kumimoji="1" lang="ja-JP" altLang="en-US" smtClean="0"/>
              <a:t>2020/9/1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58706-EEC3-45D8-A4BD-7C0559D814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190435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822" y="213572"/>
            <a:ext cx="987155" cy="747501"/>
          </a:xfrm>
        </p:spPr>
        <p:txBody>
          <a:bodyPr anchor="b"/>
          <a:lstStyle>
            <a:lvl1pPr>
              <a:defRPr sz="107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301196" y="461256"/>
            <a:ext cx="1549479" cy="2276615"/>
          </a:xfrm>
        </p:spPr>
        <p:txBody>
          <a:bodyPr/>
          <a:lstStyle>
            <a:lvl1pPr>
              <a:defRPr sz="1071"/>
            </a:lvl1pPr>
            <a:lvl2pPr>
              <a:defRPr sz="937"/>
            </a:lvl2pPr>
            <a:lvl3pPr>
              <a:defRPr sz="803"/>
            </a:lvl3pPr>
            <a:lvl4pPr>
              <a:defRPr sz="669"/>
            </a:lvl4pPr>
            <a:lvl5pPr>
              <a:defRPr sz="669"/>
            </a:lvl5pPr>
            <a:lvl6pPr>
              <a:defRPr sz="669"/>
            </a:lvl6pPr>
            <a:lvl7pPr>
              <a:defRPr sz="669"/>
            </a:lvl7pPr>
            <a:lvl8pPr>
              <a:defRPr sz="669"/>
            </a:lvl8pPr>
            <a:lvl9pPr>
              <a:defRPr sz="669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0822" y="961072"/>
            <a:ext cx="987155" cy="1780506"/>
          </a:xfrm>
        </p:spPr>
        <p:txBody>
          <a:bodyPr/>
          <a:lstStyle>
            <a:lvl1pPr marL="0" indent="0">
              <a:buNone/>
              <a:defRPr sz="536"/>
            </a:lvl1pPr>
            <a:lvl2pPr marL="153025" indent="0">
              <a:buNone/>
              <a:defRPr sz="469"/>
            </a:lvl2pPr>
            <a:lvl3pPr marL="306050" indent="0">
              <a:buNone/>
              <a:defRPr sz="402"/>
            </a:lvl3pPr>
            <a:lvl4pPr marL="459075" indent="0">
              <a:buNone/>
              <a:defRPr sz="335"/>
            </a:lvl4pPr>
            <a:lvl5pPr marL="612099" indent="0">
              <a:buNone/>
              <a:defRPr sz="335"/>
            </a:lvl5pPr>
            <a:lvl6pPr marL="765124" indent="0">
              <a:buNone/>
              <a:defRPr sz="335"/>
            </a:lvl6pPr>
            <a:lvl7pPr marL="918149" indent="0">
              <a:buNone/>
              <a:defRPr sz="335"/>
            </a:lvl7pPr>
            <a:lvl8pPr marL="1071174" indent="0">
              <a:buNone/>
              <a:defRPr sz="335"/>
            </a:lvl8pPr>
            <a:lvl9pPr marL="1224199" indent="0">
              <a:buNone/>
              <a:defRPr sz="33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A9B4-639C-428F-9083-3B99A71CCE52}" type="datetimeFigureOut">
              <a:rPr kumimoji="1" lang="ja-JP" altLang="en-US" smtClean="0"/>
              <a:t>2020/9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58706-EEC3-45D8-A4BD-7C0559D814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4255237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10822" y="213572"/>
            <a:ext cx="987155" cy="747501"/>
          </a:xfrm>
        </p:spPr>
        <p:txBody>
          <a:bodyPr anchor="b"/>
          <a:lstStyle>
            <a:lvl1pPr>
              <a:defRPr sz="1071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301196" y="461256"/>
            <a:ext cx="1549479" cy="2276615"/>
          </a:xfrm>
        </p:spPr>
        <p:txBody>
          <a:bodyPr anchor="t"/>
          <a:lstStyle>
            <a:lvl1pPr marL="0" indent="0">
              <a:buNone/>
              <a:defRPr sz="1071"/>
            </a:lvl1pPr>
            <a:lvl2pPr marL="153025" indent="0">
              <a:buNone/>
              <a:defRPr sz="937"/>
            </a:lvl2pPr>
            <a:lvl3pPr marL="306050" indent="0">
              <a:buNone/>
              <a:defRPr sz="803"/>
            </a:lvl3pPr>
            <a:lvl4pPr marL="459075" indent="0">
              <a:buNone/>
              <a:defRPr sz="669"/>
            </a:lvl4pPr>
            <a:lvl5pPr marL="612099" indent="0">
              <a:buNone/>
              <a:defRPr sz="669"/>
            </a:lvl5pPr>
            <a:lvl6pPr marL="765124" indent="0">
              <a:buNone/>
              <a:defRPr sz="669"/>
            </a:lvl6pPr>
            <a:lvl7pPr marL="918149" indent="0">
              <a:buNone/>
              <a:defRPr sz="669"/>
            </a:lvl7pPr>
            <a:lvl8pPr marL="1071174" indent="0">
              <a:buNone/>
              <a:defRPr sz="669"/>
            </a:lvl8pPr>
            <a:lvl9pPr marL="1224199" indent="0">
              <a:buNone/>
              <a:defRPr sz="669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10822" y="961072"/>
            <a:ext cx="987155" cy="1780506"/>
          </a:xfrm>
        </p:spPr>
        <p:txBody>
          <a:bodyPr/>
          <a:lstStyle>
            <a:lvl1pPr marL="0" indent="0">
              <a:buNone/>
              <a:defRPr sz="536"/>
            </a:lvl1pPr>
            <a:lvl2pPr marL="153025" indent="0">
              <a:buNone/>
              <a:defRPr sz="469"/>
            </a:lvl2pPr>
            <a:lvl3pPr marL="306050" indent="0">
              <a:buNone/>
              <a:defRPr sz="402"/>
            </a:lvl3pPr>
            <a:lvl4pPr marL="459075" indent="0">
              <a:buNone/>
              <a:defRPr sz="335"/>
            </a:lvl4pPr>
            <a:lvl5pPr marL="612099" indent="0">
              <a:buNone/>
              <a:defRPr sz="335"/>
            </a:lvl5pPr>
            <a:lvl6pPr marL="765124" indent="0">
              <a:buNone/>
              <a:defRPr sz="335"/>
            </a:lvl6pPr>
            <a:lvl7pPr marL="918149" indent="0">
              <a:buNone/>
              <a:defRPr sz="335"/>
            </a:lvl7pPr>
            <a:lvl8pPr marL="1071174" indent="0">
              <a:buNone/>
              <a:defRPr sz="335"/>
            </a:lvl8pPr>
            <a:lvl9pPr marL="1224199" indent="0">
              <a:buNone/>
              <a:defRPr sz="335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49A9B4-639C-428F-9083-3B99A71CCE52}" type="datetimeFigureOut">
              <a:rPr kumimoji="1" lang="ja-JP" altLang="en-US" smtClean="0"/>
              <a:t>2020/9/1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3E58706-EEC3-45D8-A4BD-7C0559D814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055961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210423" y="170561"/>
            <a:ext cx="2639854" cy="61921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10423" y="852803"/>
            <a:ext cx="2639854" cy="2032639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210423" y="2969240"/>
            <a:ext cx="688658" cy="1705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4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49A9B4-639C-428F-9083-3B99A71CCE52}" type="datetimeFigureOut">
              <a:rPr kumimoji="1" lang="ja-JP" altLang="en-US" smtClean="0"/>
              <a:t>2020/9/1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013857" y="2969240"/>
            <a:ext cx="1032986" cy="1705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4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161619" y="2969240"/>
            <a:ext cx="688658" cy="17056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40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3E58706-EEC3-45D8-A4BD-7C0559D8145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762826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306050" rtl="0" eaLnBrk="1" latinLnBrk="0" hangingPunct="1">
        <a:lnSpc>
          <a:spcPct val="90000"/>
        </a:lnSpc>
        <a:spcBef>
          <a:spcPct val="0"/>
        </a:spcBef>
        <a:buNone/>
        <a:defRPr kumimoji="1" sz="147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6512" indent="-76512" algn="l" defTabSz="306050" rtl="0" eaLnBrk="1" latinLnBrk="0" hangingPunct="1">
        <a:lnSpc>
          <a:spcPct val="90000"/>
        </a:lnSpc>
        <a:spcBef>
          <a:spcPts val="335"/>
        </a:spcBef>
        <a:buFont typeface="Arial" panose="020B0604020202020204" pitchFamily="34" charset="0"/>
        <a:buChar char="•"/>
        <a:defRPr kumimoji="1" sz="937" kern="1200">
          <a:solidFill>
            <a:schemeClr val="tx1"/>
          </a:solidFill>
          <a:latin typeface="+mn-lt"/>
          <a:ea typeface="+mn-ea"/>
          <a:cs typeface="+mn-cs"/>
        </a:defRPr>
      </a:lvl1pPr>
      <a:lvl2pPr marL="229537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kumimoji="1" sz="803" kern="1200">
          <a:solidFill>
            <a:schemeClr val="tx1"/>
          </a:solidFill>
          <a:latin typeface="+mn-lt"/>
          <a:ea typeface="+mn-ea"/>
          <a:cs typeface="+mn-cs"/>
        </a:defRPr>
      </a:lvl2pPr>
      <a:lvl3pPr marL="382562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kumimoji="1" sz="669" kern="1200">
          <a:solidFill>
            <a:schemeClr val="tx1"/>
          </a:solidFill>
          <a:latin typeface="+mn-lt"/>
          <a:ea typeface="+mn-ea"/>
          <a:cs typeface="+mn-cs"/>
        </a:defRPr>
      </a:lvl3pPr>
      <a:lvl4pPr marL="535587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kumimoji="1" sz="602" kern="1200">
          <a:solidFill>
            <a:schemeClr val="tx1"/>
          </a:solidFill>
          <a:latin typeface="+mn-lt"/>
          <a:ea typeface="+mn-ea"/>
          <a:cs typeface="+mn-cs"/>
        </a:defRPr>
      </a:lvl4pPr>
      <a:lvl5pPr marL="688612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kumimoji="1" sz="602" kern="1200">
          <a:solidFill>
            <a:schemeClr val="tx1"/>
          </a:solidFill>
          <a:latin typeface="+mn-lt"/>
          <a:ea typeface="+mn-ea"/>
          <a:cs typeface="+mn-cs"/>
        </a:defRPr>
      </a:lvl5pPr>
      <a:lvl6pPr marL="841637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kumimoji="1" sz="602" kern="1200">
          <a:solidFill>
            <a:schemeClr val="tx1"/>
          </a:solidFill>
          <a:latin typeface="+mn-lt"/>
          <a:ea typeface="+mn-ea"/>
          <a:cs typeface="+mn-cs"/>
        </a:defRPr>
      </a:lvl6pPr>
      <a:lvl7pPr marL="994661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kumimoji="1" sz="602" kern="1200">
          <a:solidFill>
            <a:schemeClr val="tx1"/>
          </a:solidFill>
          <a:latin typeface="+mn-lt"/>
          <a:ea typeface="+mn-ea"/>
          <a:cs typeface="+mn-cs"/>
        </a:defRPr>
      </a:lvl7pPr>
      <a:lvl8pPr marL="1147686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kumimoji="1" sz="602" kern="1200">
          <a:solidFill>
            <a:schemeClr val="tx1"/>
          </a:solidFill>
          <a:latin typeface="+mn-lt"/>
          <a:ea typeface="+mn-ea"/>
          <a:cs typeface="+mn-cs"/>
        </a:defRPr>
      </a:lvl8pPr>
      <a:lvl9pPr marL="1300711" indent="-76512" algn="l" defTabSz="306050" rtl="0" eaLnBrk="1" latinLnBrk="0" hangingPunct="1">
        <a:lnSpc>
          <a:spcPct val="90000"/>
        </a:lnSpc>
        <a:spcBef>
          <a:spcPts val="167"/>
        </a:spcBef>
        <a:buFont typeface="Arial" panose="020B0604020202020204" pitchFamily="34" charset="0"/>
        <a:buChar char="•"/>
        <a:defRPr kumimoji="1" sz="602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306050" rtl="0" eaLnBrk="1" latinLnBrk="0" hangingPunct="1">
        <a:defRPr kumimoji="1" sz="602" kern="1200">
          <a:solidFill>
            <a:schemeClr val="tx1"/>
          </a:solidFill>
          <a:latin typeface="+mn-lt"/>
          <a:ea typeface="+mn-ea"/>
          <a:cs typeface="+mn-cs"/>
        </a:defRPr>
      </a:lvl1pPr>
      <a:lvl2pPr marL="153025" algn="l" defTabSz="306050" rtl="0" eaLnBrk="1" latinLnBrk="0" hangingPunct="1">
        <a:defRPr kumimoji="1" sz="602" kern="1200">
          <a:solidFill>
            <a:schemeClr val="tx1"/>
          </a:solidFill>
          <a:latin typeface="+mn-lt"/>
          <a:ea typeface="+mn-ea"/>
          <a:cs typeface="+mn-cs"/>
        </a:defRPr>
      </a:lvl2pPr>
      <a:lvl3pPr marL="306050" algn="l" defTabSz="306050" rtl="0" eaLnBrk="1" latinLnBrk="0" hangingPunct="1">
        <a:defRPr kumimoji="1" sz="602" kern="1200">
          <a:solidFill>
            <a:schemeClr val="tx1"/>
          </a:solidFill>
          <a:latin typeface="+mn-lt"/>
          <a:ea typeface="+mn-ea"/>
          <a:cs typeface="+mn-cs"/>
        </a:defRPr>
      </a:lvl3pPr>
      <a:lvl4pPr marL="459075" algn="l" defTabSz="306050" rtl="0" eaLnBrk="1" latinLnBrk="0" hangingPunct="1">
        <a:defRPr kumimoji="1" sz="602" kern="1200">
          <a:solidFill>
            <a:schemeClr val="tx1"/>
          </a:solidFill>
          <a:latin typeface="+mn-lt"/>
          <a:ea typeface="+mn-ea"/>
          <a:cs typeface="+mn-cs"/>
        </a:defRPr>
      </a:lvl4pPr>
      <a:lvl5pPr marL="612099" algn="l" defTabSz="306050" rtl="0" eaLnBrk="1" latinLnBrk="0" hangingPunct="1">
        <a:defRPr kumimoji="1" sz="602" kern="1200">
          <a:solidFill>
            <a:schemeClr val="tx1"/>
          </a:solidFill>
          <a:latin typeface="+mn-lt"/>
          <a:ea typeface="+mn-ea"/>
          <a:cs typeface="+mn-cs"/>
        </a:defRPr>
      </a:lvl5pPr>
      <a:lvl6pPr marL="765124" algn="l" defTabSz="306050" rtl="0" eaLnBrk="1" latinLnBrk="0" hangingPunct="1">
        <a:defRPr kumimoji="1" sz="602" kern="1200">
          <a:solidFill>
            <a:schemeClr val="tx1"/>
          </a:solidFill>
          <a:latin typeface="+mn-lt"/>
          <a:ea typeface="+mn-ea"/>
          <a:cs typeface="+mn-cs"/>
        </a:defRPr>
      </a:lvl6pPr>
      <a:lvl7pPr marL="918149" algn="l" defTabSz="306050" rtl="0" eaLnBrk="1" latinLnBrk="0" hangingPunct="1">
        <a:defRPr kumimoji="1" sz="602" kern="1200">
          <a:solidFill>
            <a:schemeClr val="tx1"/>
          </a:solidFill>
          <a:latin typeface="+mn-lt"/>
          <a:ea typeface="+mn-ea"/>
          <a:cs typeface="+mn-cs"/>
        </a:defRPr>
      </a:lvl7pPr>
      <a:lvl8pPr marL="1071174" algn="l" defTabSz="306050" rtl="0" eaLnBrk="1" latinLnBrk="0" hangingPunct="1">
        <a:defRPr kumimoji="1" sz="602" kern="1200">
          <a:solidFill>
            <a:schemeClr val="tx1"/>
          </a:solidFill>
          <a:latin typeface="+mn-lt"/>
          <a:ea typeface="+mn-ea"/>
          <a:cs typeface="+mn-cs"/>
        </a:defRPr>
      </a:lvl8pPr>
      <a:lvl9pPr marL="1224199" algn="l" defTabSz="306050" rtl="0" eaLnBrk="1" latinLnBrk="0" hangingPunct="1">
        <a:defRPr kumimoji="1" sz="602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図 3">
            <a:extLst>
              <a:ext uri="{FF2B5EF4-FFF2-40B4-BE49-F238E27FC236}">
                <a16:creationId xmlns:a16="http://schemas.microsoft.com/office/drawing/2014/main" id="{9CC1B7EB-4183-4D42-ADAD-00E3296D567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17236" r="9268"/>
          <a:stretch/>
        </p:blipFill>
        <p:spPr>
          <a:xfrm>
            <a:off x="376517" y="90020"/>
            <a:ext cx="2431229" cy="2643079"/>
          </a:xfrm>
          <a:prstGeom prst="rect">
            <a:avLst/>
          </a:prstGeom>
        </p:spPr>
      </p:pic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86A93BB5-6426-47DE-85BA-1844E405139D}"/>
              </a:ext>
            </a:extLst>
          </p:cNvPr>
          <p:cNvSpPr txBox="1"/>
          <p:nvPr/>
        </p:nvSpPr>
        <p:spPr>
          <a:xfrm>
            <a:off x="415455" y="2576031"/>
            <a:ext cx="23468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 - specificity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6FA8F7D7-5714-4DA4-9344-6CCE66DDC14A}"/>
              </a:ext>
            </a:extLst>
          </p:cNvPr>
          <p:cNvSpPr txBox="1"/>
          <p:nvPr/>
        </p:nvSpPr>
        <p:spPr>
          <a:xfrm rot="16200000">
            <a:off x="-1169656" y="1167453"/>
            <a:ext cx="2564145" cy="2215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ensitivity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A4222D44-51AD-452E-BB09-DDF401BB9DB7}"/>
              </a:ext>
            </a:extLst>
          </p:cNvPr>
          <p:cNvSpPr txBox="1"/>
          <p:nvPr/>
        </p:nvSpPr>
        <p:spPr>
          <a:xfrm>
            <a:off x="250834" y="2427523"/>
            <a:ext cx="3611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FB18B2D4-CF23-47C7-A903-D0F13D3E4CB0}"/>
              </a:ext>
            </a:extLst>
          </p:cNvPr>
          <p:cNvSpPr txBox="1"/>
          <p:nvPr/>
        </p:nvSpPr>
        <p:spPr>
          <a:xfrm>
            <a:off x="718090" y="2425237"/>
            <a:ext cx="3611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>
            <a:extLst>
              <a:ext uri="{FF2B5EF4-FFF2-40B4-BE49-F238E27FC236}">
                <a16:creationId xmlns:a16="http://schemas.microsoft.com/office/drawing/2014/main" id="{8CCC5B38-37CE-4E15-B1F4-3890C24F2CC3}"/>
              </a:ext>
            </a:extLst>
          </p:cNvPr>
          <p:cNvSpPr txBox="1"/>
          <p:nvPr/>
        </p:nvSpPr>
        <p:spPr>
          <a:xfrm>
            <a:off x="1183074" y="2427522"/>
            <a:ext cx="3611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>
            <a:extLst>
              <a:ext uri="{FF2B5EF4-FFF2-40B4-BE49-F238E27FC236}">
                <a16:creationId xmlns:a16="http://schemas.microsoft.com/office/drawing/2014/main" id="{E46D3B48-9F3E-47F2-B0A6-7B4E8819D6F3}"/>
              </a:ext>
            </a:extLst>
          </p:cNvPr>
          <p:cNvSpPr txBox="1"/>
          <p:nvPr/>
        </p:nvSpPr>
        <p:spPr>
          <a:xfrm>
            <a:off x="1650470" y="2427522"/>
            <a:ext cx="3611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>
            <a:extLst>
              <a:ext uri="{FF2B5EF4-FFF2-40B4-BE49-F238E27FC236}">
                <a16:creationId xmlns:a16="http://schemas.microsoft.com/office/drawing/2014/main" id="{35026712-733B-4968-8BCE-4553E746B86C}"/>
              </a:ext>
            </a:extLst>
          </p:cNvPr>
          <p:cNvSpPr txBox="1"/>
          <p:nvPr/>
        </p:nvSpPr>
        <p:spPr>
          <a:xfrm>
            <a:off x="2115456" y="2425234"/>
            <a:ext cx="3611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>
            <a:extLst>
              <a:ext uri="{FF2B5EF4-FFF2-40B4-BE49-F238E27FC236}">
                <a16:creationId xmlns:a16="http://schemas.microsoft.com/office/drawing/2014/main" id="{71844631-C362-44E9-AE83-41F8CC9BDEAC}"/>
              </a:ext>
            </a:extLst>
          </p:cNvPr>
          <p:cNvSpPr txBox="1"/>
          <p:nvPr/>
        </p:nvSpPr>
        <p:spPr>
          <a:xfrm>
            <a:off x="115165" y="5244"/>
            <a:ext cx="3497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>
            <a:extLst>
              <a:ext uri="{FF2B5EF4-FFF2-40B4-BE49-F238E27FC236}">
                <a16:creationId xmlns:a16="http://schemas.microsoft.com/office/drawing/2014/main" id="{36710478-F4AB-4C49-8EB4-E6615FE38AE0}"/>
              </a:ext>
            </a:extLst>
          </p:cNvPr>
          <p:cNvSpPr txBox="1"/>
          <p:nvPr/>
        </p:nvSpPr>
        <p:spPr>
          <a:xfrm>
            <a:off x="112822" y="471823"/>
            <a:ext cx="3497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8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81C6F0E8-B356-463A-A871-C10B1180F78C}"/>
              </a:ext>
            </a:extLst>
          </p:cNvPr>
          <p:cNvSpPr txBox="1"/>
          <p:nvPr/>
        </p:nvSpPr>
        <p:spPr>
          <a:xfrm>
            <a:off x="112820" y="936051"/>
            <a:ext cx="3497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6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16D9507F-1FDB-4095-8CE6-A0D356D63E08}"/>
              </a:ext>
            </a:extLst>
          </p:cNvPr>
          <p:cNvSpPr txBox="1"/>
          <p:nvPr/>
        </p:nvSpPr>
        <p:spPr>
          <a:xfrm>
            <a:off x="112820" y="1400284"/>
            <a:ext cx="3497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4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621960A2-B3E1-477B-B7A2-21F4C37550A5}"/>
              </a:ext>
            </a:extLst>
          </p:cNvPr>
          <p:cNvSpPr txBox="1"/>
          <p:nvPr/>
        </p:nvSpPr>
        <p:spPr>
          <a:xfrm>
            <a:off x="112822" y="1864511"/>
            <a:ext cx="3497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.2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>
            <a:extLst>
              <a:ext uri="{FF2B5EF4-FFF2-40B4-BE49-F238E27FC236}">
                <a16:creationId xmlns:a16="http://schemas.microsoft.com/office/drawing/2014/main" id="{925E0B73-2F39-467D-94FE-220B43F344ED}"/>
              </a:ext>
            </a:extLst>
          </p:cNvPr>
          <p:cNvSpPr txBox="1"/>
          <p:nvPr/>
        </p:nvSpPr>
        <p:spPr>
          <a:xfrm>
            <a:off x="112821" y="2328753"/>
            <a:ext cx="3497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>
            <a:extLst>
              <a:ext uri="{FF2B5EF4-FFF2-40B4-BE49-F238E27FC236}">
                <a16:creationId xmlns:a16="http://schemas.microsoft.com/office/drawing/2014/main" id="{554D45A1-A3DC-45CC-B009-2E69E61C8059}"/>
              </a:ext>
            </a:extLst>
          </p:cNvPr>
          <p:cNvSpPr txBox="1"/>
          <p:nvPr/>
        </p:nvSpPr>
        <p:spPr>
          <a:xfrm>
            <a:off x="1622" y="2744673"/>
            <a:ext cx="305908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altLang="ja-JP" sz="800" b="1" kern="100" dirty="0">
                <a:latin typeface="Times New Roman" panose="02020603050405020304" pitchFamily="18" charset="0"/>
                <a:ea typeface="ＭＳ Ｐゴシック" panose="020B0600070205080204" pitchFamily="50" charset="-128"/>
              </a:rPr>
              <a:t>Additional file 3. </a:t>
            </a:r>
            <a:r>
              <a:rPr lang="en-US" altLang="ja-JP" sz="8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he ROC curve of the change in the number of medications for recovery to oral feeding. </a:t>
            </a:r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OC, receiver operating characteristic; AUC, area under the curve.</a:t>
            </a:r>
            <a:endParaRPr lang="ja-JP" altLang="ja-JP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>
            <a:extLst>
              <a:ext uri="{FF2B5EF4-FFF2-40B4-BE49-F238E27FC236}">
                <a16:creationId xmlns:a16="http://schemas.microsoft.com/office/drawing/2014/main" id="{F2E950C0-4CF6-4833-95D1-CCA306E1B9AD}"/>
              </a:ext>
            </a:extLst>
          </p:cNvPr>
          <p:cNvSpPr txBox="1"/>
          <p:nvPr/>
        </p:nvSpPr>
        <p:spPr>
          <a:xfrm>
            <a:off x="2579805" y="2425232"/>
            <a:ext cx="36118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.0</a:t>
            </a:r>
            <a:endParaRPr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48D9B93-B693-473C-AC8B-720FE96330EF}"/>
              </a:ext>
            </a:extLst>
          </p:cNvPr>
          <p:cNvSpPr txBox="1"/>
          <p:nvPr/>
        </p:nvSpPr>
        <p:spPr>
          <a:xfrm>
            <a:off x="1972546" y="2099852"/>
            <a:ext cx="7837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UC: 0.636</a:t>
            </a:r>
          </a:p>
          <a:p>
            <a:pPr algn="r"/>
            <a:r>
              <a:rPr kumimoji="1" lang="en-US" altLang="ja-JP" sz="8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 = 0.027</a:t>
            </a:r>
            <a:endParaRPr kumimoji="1" lang="ja-JP" altLang="en-US" sz="8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029777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90</TotalTime>
  <Words>56</Words>
  <Application>Microsoft Office PowerPoint</Application>
  <PresentationFormat>ユーザー設定</PresentationFormat>
  <Paragraphs>1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Kentaro Oniki</dc:creator>
  <cp:lastModifiedBy>猿渡 淳二</cp:lastModifiedBy>
  <cp:revision>20</cp:revision>
  <dcterms:created xsi:type="dcterms:W3CDTF">2019-02-18T05:53:47Z</dcterms:created>
  <dcterms:modified xsi:type="dcterms:W3CDTF">2020-09-12T03:14:57Z</dcterms:modified>
</cp:coreProperties>
</file>